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11.jpeg" ContentType="image/jpe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32404050" cy="43206988"/>
  <p:notesSz cx="9925050" cy="14352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925200" cy="14353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4302000" cy="717480"/>
          </a:xfrm>
          <a:prstGeom prst="rect">
            <a:avLst/>
          </a:prstGeom>
          <a:noFill/>
          <a:ln w="0">
            <a:noFill/>
          </a:ln>
        </p:spPr>
        <p:txBody>
          <a:bodyPr lIns="132840" rIns="132840" tIns="66240" bIns="66240" anchor="t">
            <a:noAutofit/>
          </a:bodyPr>
          <a:p>
            <a:pPr indent="0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622480" y="-360"/>
            <a:ext cx="4302360" cy="717480"/>
          </a:xfrm>
          <a:prstGeom prst="rect">
            <a:avLst/>
          </a:prstGeom>
          <a:noFill/>
          <a:ln w="0">
            <a:noFill/>
          </a:ln>
        </p:spPr>
        <p:txBody>
          <a:bodyPr lIns="132840" rIns="132840" tIns="66240" bIns="66240" anchor="t">
            <a:noAutofit/>
          </a:bodyPr>
          <a:lstStyle>
            <a:lvl1pPr indent="0" algn="r">
              <a:buNone/>
              <a:tabLst>
                <a:tab algn="l" pos="0"/>
                <a:tab algn="l" pos="4319640"/>
                <a:tab algn="l" pos="8639280"/>
              </a:tabLst>
              <a:defRPr b="0" lang="en-US" sz="17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319640"/>
                <a:tab algn="l" pos="863928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944800" y="1076040"/>
            <a:ext cx="4037040" cy="5383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132840" rIns="132840" tIns="66240" bIns="6624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r>
              <a:rPr b="0" lang="en-US" sz="208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92160" y="6816600"/>
            <a:ext cx="7942320" cy="6459840"/>
          </a:xfrm>
          <a:prstGeom prst="rect">
            <a:avLst/>
          </a:prstGeom>
          <a:noFill/>
          <a:ln w="0">
            <a:noFill/>
          </a:ln>
        </p:spPr>
        <p:txBody>
          <a:bodyPr lIns="132840" rIns="132840" tIns="66240" bIns="66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13631400"/>
            <a:ext cx="4302000" cy="717480"/>
          </a:xfrm>
          <a:prstGeom prst="rect">
            <a:avLst/>
          </a:prstGeom>
          <a:noFill/>
          <a:ln w="0">
            <a:noFill/>
          </a:ln>
        </p:spPr>
        <p:txBody>
          <a:bodyPr lIns="132840" rIns="132840" tIns="66240" bIns="66240" anchor="b">
            <a:noAutofit/>
          </a:bodyPr>
          <a:p>
            <a:pPr indent="0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622480" y="13631400"/>
            <a:ext cx="4302360" cy="717480"/>
          </a:xfrm>
          <a:prstGeom prst="rect">
            <a:avLst/>
          </a:prstGeom>
          <a:noFill/>
          <a:ln w="0">
            <a:noFill/>
          </a:ln>
        </p:spPr>
        <p:txBody>
          <a:bodyPr lIns="132840" rIns="132840" tIns="66240" bIns="66240" anchor="b">
            <a:noAutofit/>
          </a:bodyPr>
          <a:lstStyle>
            <a:lvl1pPr indent="0" algn="r">
              <a:buNone/>
              <a:tabLst>
                <a:tab algn="l" pos="0"/>
                <a:tab algn="l" pos="4319640"/>
                <a:tab algn="l" pos="8639280"/>
              </a:tabLst>
              <a:defRPr b="0" lang="en-US" sz="17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319640"/>
                <a:tab algn="l" pos="8639280"/>
              </a:tabLst>
            </a:pPr>
            <a:fld id="{1F988188-437D-4777-8445-32DE0DA770B3}" type="slidenum">
              <a:rPr b="0" lang="en-US" sz="17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sldImg"/>
          </p:nvPr>
        </p:nvSpPr>
        <p:spPr>
          <a:xfrm>
            <a:off x="2944800" y="1076400"/>
            <a:ext cx="4037040" cy="5383080"/>
          </a:xfrm>
          <a:prstGeom prst="rect">
            <a:avLst/>
          </a:prstGeom>
          <a:ln w="0">
            <a:noFill/>
          </a:ln>
        </p:spPr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992160" y="6816600"/>
            <a:ext cx="7942320" cy="6459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Espace réservé du numéro de diapositive 3"/>
          <p:cNvSpPr/>
          <p:nvPr/>
        </p:nvSpPr>
        <p:spPr>
          <a:xfrm>
            <a:off x="5622840" y="13631760"/>
            <a:ext cx="4302360" cy="71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32840" rIns="132840" tIns="66240" bIns="66240" anchor="b">
            <a:noAutofit/>
          </a:bodyPr>
          <a:p>
            <a:pPr algn="r">
              <a:tabLst>
                <a:tab algn="l" pos="0"/>
                <a:tab algn="l" pos="4319640"/>
                <a:tab algn="l" pos="8639280"/>
              </a:tabLst>
            </a:pPr>
            <a:fld id="{F29025EB-07FF-4582-9D6E-34F99470F74F}" type="slidenum">
              <a:rPr b="0" lang="en-US" sz="17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D044C0-9ED9-4183-A9C7-48D645756B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620360" y="1730520"/>
            <a:ext cx="29162520" cy="72007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620360" y="10080360"/>
            <a:ext cx="2916252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620360" y="24973920"/>
            <a:ext cx="2916252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115CE-674E-4F70-B590-628D547E49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620360" y="1730520"/>
            <a:ext cx="29162520" cy="72007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620360" y="10080360"/>
            <a:ext cx="1423116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6563600" y="10080360"/>
            <a:ext cx="1423116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620360" y="24973920"/>
            <a:ext cx="1423116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6563600" y="24973920"/>
            <a:ext cx="1423116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B6AF4-0BBE-4E10-815B-96318F1BB0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620360" y="1730520"/>
            <a:ext cx="29162520" cy="72007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620360" y="10080360"/>
            <a:ext cx="939024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1480400" y="10080360"/>
            <a:ext cx="939024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1340800" y="10080360"/>
            <a:ext cx="939024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620360" y="24973920"/>
            <a:ext cx="939024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1480400" y="24973920"/>
            <a:ext cx="939024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1340800" y="24973920"/>
            <a:ext cx="939024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DE8840-217F-43CE-942F-3E0C0BB2E5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620360" y="1730520"/>
            <a:ext cx="29162520" cy="72007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620360" y="10080360"/>
            <a:ext cx="29162520" cy="28514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776"/>
              </a:spcBef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848CA-5E28-470E-ACC6-A723D43A0A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620360" y="1730520"/>
            <a:ext cx="29162520" cy="72007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620360" y="10080360"/>
            <a:ext cx="29162520" cy="285145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4E1C4F-51D4-4C40-8240-9AD3B70896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620360" y="1730520"/>
            <a:ext cx="29162520" cy="72007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620360" y="10080360"/>
            <a:ext cx="14231160" cy="285145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6563600" y="10080360"/>
            <a:ext cx="14231160" cy="285145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93698F-973C-4ADA-8D40-BB1F315CF1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620360" y="1730520"/>
            <a:ext cx="29162520" cy="72007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79140C-14AC-4EDE-9046-DAF0B4B1C9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620360" y="1730520"/>
            <a:ext cx="29162520" cy="3337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776"/>
              </a:spcBef>
              <a:tabLst>
                <a:tab algn="l" pos="0"/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0E9EB-1B70-4D92-9433-8B8E6A7C65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620360" y="1730520"/>
            <a:ext cx="29162520" cy="72007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620360" y="10080360"/>
            <a:ext cx="1423116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6563600" y="10080360"/>
            <a:ext cx="14231160" cy="285145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620360" y="24973920"/>
            <a:ext cx="1423116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BB7943-CA2D-430B-9273-DABFA9F269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620360" y="1730520"/>
            <a:ext cx="29162520" cy="72007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620360" y="10080360"/>
            <a:ext cx="14231160" cy="285145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6563600" y="10080360"/>
            <a:ext cx="1423116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6563600" y="24973920"/>
            <a:ext cx="1423116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712C6E-A011-4D0B-BE18-70A71697D0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620360" y="1730520"/>
            <a:ext cx="29162520" cy="72007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620360" y="10080360"/>
            <a:ext cx="1423116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6563600" y="10080360"/>
            <a:ext cx="1423116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620360" y="24973920"/>
            <a:ext cx="29162520" cy="1360116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indent="0">
              <a:spcBef>
                <a:spcPts val="3776"/>
              </a:spcBef>
              <a:buNone/>
              <a:tabLst>
                <a:tab algn="l" pos="4319640"/>
                <a:tab algn="l" pos="863928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59D30C-0439-4740-B2AA-82294A5F7E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620360" y="1730520"/>
            <a:ext cx="29162520" cy="72007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 algn="ctr">
              <a:buNone/>
              <a:tabLst>
                <a:tab algn="l" pos="0"/>
                <a:tab algn="l" pos="4319640"/>
                <a:tab algn="l" pos="8639280"/>
              </a:tabLst>
            </a:pPr>
            <a:r>
              <a:rPr b="0" lang="en-US" sz="20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0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620360" y="10080360"/>
            <a:ext cx="29162520" cy="2851452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t">
            <a:normAutofit/>
          </a:bodyPr>
          <a:p>
            <a:pPr marL="1619280" indent="-1619280">
              <a:spcBef>
                <a:spcPts val="3776"/>
              </a:spcBef>
              <a:buClr>
                <a:srgbClr val="000000"/>
              </a:buClr>
              <a:buFont typeface="Arial"/>
              <a:buChar char="•"/>
              <a:tabLst>
                <a:tab algn="l" pos="4319640"/>
                <a:tab algn="l" pos="8639280"/>
              </a:tabLst>
            </a:pPr>
            <a:r>
              <a:rPr b="0" lang="en-US" sz="15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  <a:p>
            <a:pPr lvl="1" marL="3510000" indent="-1349280">
              <a:spcBef>
                <a:spcPts val="3776"/>
              </a:spcBef>
              <a:buClr>
                <a:srgbClr val="000000"/>
              </a:buClr>
              <a:buFont typeface="Arial"/>
              <a:buChar char="–"/>
              <a:tabLst>
                <a:tab algn="l" pos="4319640"/>
                <a:tab algn="l" pos="8639280"/>
              </a:tabLst>
            </a:pPr>
            <a:r>
              <a:rPr b="0" lang="en-US" sz="15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  <a:p>
            <a:pPr lvl="2" marL="5400720" indent="-1079640">
              <a:spcBef>
                <a:spcPts val="3776"/>
              </a:spcBef>
              <a:buClr>
                <a:srgbClr val="000000"/>
              </a:buClr>
              <a:buFont typeface="Arial"/>
              <a:buChar char="•"/>
              <a:tabLst>
                <a:tab algn="l" pos="4319640"/>
                <a:tab algn="l" pos="8639280"/>
              </a:tabLst>
            </a:pPr>
            <a:r>
              <a:rPr b="0" lang="en-US" sz="15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  <a:p>
            <a:pPr lvl="3" marL="7559640" indent="-1079640">
              <a:spcBef>
                <a:spcPts val="3776"/>
              </a:spcBef>
              <a:buClr>
                <a:srgbClr val="000000"/>
              </a:buClr>
              <a:buFont typeface="Arial"/>
              <a:buChar char="–"/>
              <a:tabLst>
                <a:tab algn="l" pos="4319640"/>
                <a:tab algn="l" pos="8639280"/>
              </a:tabLst>
            </a:pPr>
            <a:r>
              <a:rPr b="0" lang="en-US" sz="15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  <a:p>
            <a:pPr lvl="4" marL="9720360" indent="-1079640">
              <a:spcBef>
                <a:spcPts val="3776"/>
              </a:spcBef>
              <a:buClr>
                <a:srgbClr val="000000"/>
              </a:buClr>
              <a:buFont typeface="Arial"/>
              <a:buChar char="»"/>
              <a:tabLst>
                <a:tab algn="l" pos="4319640"/>
                <a:tab algn="l" pos="8639280"/>
              </a:tabLst>
            </a:pPr>
            <a:r>
              <a:rPr b="0" lang="en-US" sz="15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  <a:p>
            <a:pPr lvl="5" marL="9720360" indent="-1079640">
              <a:spcBef>
                <a:spcPts val="3776"/>
              </a:spcBef>
              <a:buClr>
                <a:srgbClr val="000000"/>
              </a:buClr>
              <a:buFont typeface="Arial"/>
              <a:buChar char="»"/>
              <a:tabLst>
                <a:tab algn="l" pos="4319640"/>
                <a:tab algn="l" pos="8639280"/>
              </a:tabLst>
            </a:pPr>
            <a:r>
              <a:rPr b="0" lang="en-US" sz="15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  <a:p>
            <a:pPr lvl="6" marL="9720360" indent="-1079640">
              <a:spcBef>
                <a:spcPts val="3776"/>
              </a:spcBef>
              <a:buClr>
                <a:srgbClr val="000000"/>
              </a:buClr>
              <a:buFont typeface="Arial"/>
              <a:buChar char="»"/>
              <a:tabLst>
                <a:tab algn="l" pos="4319640"/>
                <a:tab algn="l" pos="8639280"/>
              </a:tabLst>
            </a:pPr>
            <a:r>
              <a:rPr b="0" lang="en-US" sz="15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620360" y="40044600"/>
            <a:ext cx="7559640" cy="230040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lstStyle>
            <a:lvl1pPr indent="0">
              <a:buNone/>
              <a:tabLst>
                <a:tab algn="l" pos="0"/>
                <a:tab algn="l" pos="4319640"/>
                <a:tab algn="l" pos="8639280"/>
              </a:tabLst>
              <a:defRPr b="0" lang="fr-FR" sz="5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319640"/>
                <a:tab algn="l" pos="8639280"/>
              </a:tabLst>
            </a:pPr>
            <a:r>
              <a:rPr b="0" lang="fr-FR" sz="5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1070720" y="40044600"/>
            <a:ext cx="10261800" cy="230040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p>
            <a:pPr indent="0">
              <a:buNone/>
              <a:tabLst>
                <a:tab algn="l" pos="0"/>
                <a:tab algn="l" pos="4319640"/>
                <a:tab algn="l" pos="863928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3223240" y="40044600"/>
            <a:ext cx="7559640" cy="2300400"/>
          </a:xfrm>
          <a:prstGeom prst="rect">
            <a:avLst/>
          </a:prstGeom>
          <a:noFill/>
          <a:ln w="0">
            <a:noFill/>
          </a:ln>
        </p:spPr>
        <p:txBody>
          <a:bodyPr lIns="432000" rIns="432000" tIns="216000" bIns="216000" anchor="ctr">
            <a:noAutofit/>
          </a:bodyPr>
          <a:lstStyle>
            <a:lvl1pPr indent="0" algn="r">
              <a:buNone/>
              <a:tabLst>
                <a:tab algn="l" pos="0"/>
                <a:tab algn="l" pos="4319640"/>
                <a:tab algn="l" pos="8639280"/>
              </a:tabLst>
              <a:defRPr b="0" lang="fr-FR" sz="5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319640"/>
                <a:tab algn="l" pos="8639280"/>
              </a:tabLst>
            </a:pPr>
            <a:fld id="{CF591CD4-608E-402F-840B-D72E958A8260}" type="slidenum">
              <a:rPr b="0" lang="fr-FR" sz="5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5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8.png"/><Relationship Id="rId10" Type="http://schemas.openxmlformats.org/officeDocument/2006/relationships/image" Target="../media/image8.png"/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image" Target="../media/image11.jpeg"/><Relationship Id="rId14" Type="http://schemas.openxmlformats.org/officeDocument/2006/relationships/slideLayout" Target="../slideLayouts/slideLayout1.xml"/><Relationship Id="rId1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44"/>
          <p:cNvSpPr/>
          <p:nvPr/>
        </p:nvSpPr>
        <p:spPr>
          <a:xfrm>
            <a:off x="4897440" y="720720"/>
            <a:ext cx="22609080" cy="3024360"/>
          </a:xfrm>
          <a:prstGeom prst="rect">
            <a:avLst/>
          </a:prstGeom>
          <a:solidFill>
            <a:srgbClr val="dce6f2"/>
          </a:solidFill>
          <a:ln w="25560">
            <a:solidFill>
              <a:srgbClr val="385d8a">
                <a:alpha val="0"/>
              </a:srgbClr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319640"/>
                <a:tab algn="l" pos="8639280"/>
              </a:tabLst>
            </a:pPr>
            <a:endParaRPr b="0" lang="en-US" sz="85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Image 2" descr=""/>
          <p:cNvPicPr/>
          <p:nvPr/>
        </p:nvPicPr>
        <p:blipFill>
          <a:blip r:embed="rId1"/>
          <a:stretch/>
        </p:blipFill>
        <p:spPr>
          <a:xfrm>
            <a:off x="1440000" y="16978320"/>
            <a:ext cx="9512280" cy="14319360"/>
          </a:xfrm>
          <a:prstGeom prst="rect">
            <a:avLst/>
          </a:prstGeom>
          <a:ln w="0">
            <a:noFill/>
          </a:ln>
        </p:spPr>
      </p:pic>
      <p:pic>
        <p:nvPicPr>
          <p:cNvPr id="50" name="Image 4" descr=""/>
          <p:cNvPicPr/>
          <p:nvPr/>
        </p:nvPicPr>
        <p:blipFill>
          <a:blip r:embed="rId2"/>
          <a:stretch/>
        </p:blipFill>
        <p:spPr>
          <a:xfrm>
            <a:off x="5587920" y="41060520"/>
            <a:ext cx="4035600" cy="1314720"/>
          </a:xfrm>
          <a:prstGeom prst="rect">
            <a:avLst/>
          </a:prstGeom>
          <a:ln w="0">
            <a:noFill/>
          </a:ln>
        </p:spPr>
      </p:pic>
      <p:pic>
        <p:nvPicPr>
          <p:cNvPr id="51" name="Rectangle 5" descr=""/>
          <p:cNvPicPr/>
          <p:nvPr/>
        </p:nvPicPr>
        <p:blipFill>
          <a:blip r:embed="rId3"/>
          <a:stretch/>
        </p:blipFill>
        <p:spPr>
          <a:xfrm>
            <a:off x="5791320" y="585720"/>
            <a:ext cx="20823120" cy="2992680"/>
          </a:xfrm>
          <a:prstGeom prst="rect">
            <a:avLst/>
          </a:prstGeom>
          <a:ln w="0">
            <a:noFill/>
          </a:ln>
        </p:spPr>
      </p:pic>
      <p:pic>
        <p:nvPicPr>
          <p:cNvPr id="52" name="Image 1" descr=""/>
          <p:cNvPicPr/>
          <p:nvPr/>
        </p:nvPicPr>
        <p:blipFill>
          <a:blip r:embed="rId4"/>
          <a:srcRect l="0" t="0" r="0" b="11118"/>
          <a:stretch/>
        </p:blipFill>
        <p:spPr>
          <a:xfrm>
            <a:off x="22826520" y="36152280"/>
            <a:ext cx="8047080" cy="5302080"/>
          </a:xfrm>
          <a:prstGeom prst="rect">
            <a:avLst/>
          </a:prstGeom>
          <a:ln w="0">
            <a:noFill/>
          </a:ln>
        </p:spPr>
      </p:pic>
      <p:pic>
        <p:nvPicPr>
          <p:cNvPr id="53" name="Image 2" descr=""/>
          <p:cNvPicPr/>
          <p:nvPr/>
        </p:nvPicPr>
        <p:blipFill>
          <a:blip r:embed="rId5"/>
          <a:stretch/>
        </p:blipFill>
        <p:spPr>
          <a:xfrm>
            <a:off x="19215000" y="22469400"/>
            <a:ext cx="10080720" cy="6139080"/>
          </a:xfrm>
          <a:prstGeom prst="rect">
            <a:avLst/>
          </a:prstGeom>
          <a:ln w="0">
            <a:noFill/>
          </a:ln>
        </p:spPr>
      </p:pic>
      <p:pic>
        <p:nvPicPr>
          <p:cNvPr id="54" name="Image 3" descr=""/>
          <p:cNvPicPr/>
          <p:nvPr/>
        </p:nvPicPr>
        <p:blipFill>
          <a:blip r:embed="rId6"/>
          <a:srcRect l="4217" t="0" r="4713" b="0"/>
          <a:stretch/>
        </p:blipFill>
        <p:spPr>
          <a:xfrm>
            <a:off x="19215000" y="29314800"/>
            <a:ext cx="10080720" cy="6084720"/>
          </a:xfrm>
          <a:prstGeom prst="rect">
            <a:avLst/>
          </a:prstGeom>
          <a:ln w="0">
            <a:noFill/>
          </a:ln>
        </p:spPr>
      </p:pic>
      <p:pic>
        <p:nvPicPr>
          <p:cNvPr id="55" name="Image 8" descr=""/>
          <p:cNvPicPr/>
          <p:nvPr/>
        </p:nvPicPr>
        <p:blipFill>
          <a:blip r:embed="rId7"/>
          <a:stretch/>
        </p:blipFill>
        <p:spPr>
          <a:xfrm>
            <a:off x="16849800" y="36187200"/>
            <a:ext cx="5684760" cy="5937120"/>
          </a:xfrm>
          <a:prstGeom prst="rect">
            <a:avLst/>
          </a:prstGeom>
          <a:ln w="0">
            <a:noFill/>
          </a:ln>
        </p:spPr>
      </p:pic>
      <p:sp>
        <p:nvSpPr>
          <p:cNvPr id="56" name="ZoneTexte 10"/>
          <p:cNvSpPr/>
          <p:nvPr/>
        </p:nvSpPr>
        <p:spPr>
          <a:xfrm>
            <a:off x="1512720" y="6337440"/>
            <a:ext cx="13681080" cy="55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319640"/>
                <a:tab algn="l" pos="8639280"/>
              </a:tabLst>
            </a:pPr>
            <a:r>
              <a:rPr b="1" lang="fr-FR" sz="3600" spc="-1" strike="noStrike">
                <a:solidFill>
                  <a:srgbClr val="cc6600"/>
                </a:solidFill>
                <a:latin typeface="Calibri"/>
              </a:rPr>
              <a:t>Context: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4319640"/>
                <a:tab algn="l" pos="8639280"/>
              </a:tabLst>
            </a:pP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Genotyping of pathogens is essential for epidemiological surveillance</a:t>
            </a:r>
            <a:r>
              <a:rPr b="0" i="1" lang="fr-FR" sz="3600" spc="-1" strike="noStrike">
                <a:solidFill>
                  <a:srgbClr val="000000"/>
                </a:solidFill>
                <a:latin typeface="Calibri"/>
              </a:rPr>
              <a:t>. Bacillus anthracis 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strains</a:t>
            </a:r>
            <a:r>
              <a:rPr b="0" i="1" lang="fr-FR" sz="36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are most commonly genotyped with multiple tandem repeats (VNTRs) constituting  </a:t>
            </a:r>
            <a:r>
              <a:rPr b="1" lang="fr-FR" sz="3600" spc="-1" strike="noStrike">
                <a:solidFill>
                  <a:srgbClr val="000000"/>
                </a:solidFill>
                <a:latin typeface="Calibri"/>
              </a:rPr>
              <a:t>MLVA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 assays, and with single nucleotide polymorphisms (</a:t>
            </a:r>
            <a:r>
              <a:rPr b="1" lang="fr-FR" sz="3600" spc="-1" strike="noStrike">
                <a:solidFill>
                  <a:srgbClr val="000000"/>
                </a:solidFill>
                <a:latin typeface="Calibri"/>
              </a:rPr>
              <a:t>SNPs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) as first-line assays, before </a:t>
            </a:r>
            <a:r>
              <a:rPr b="1" lang="fr-FR" sz="3600" spc="-1" strike="noStrike">
                <a:solidFill>
                  <a:srgbClr val="000000"/>
                </a:solidFill>
                <a:latin typeface="Calibri"/>
              </a:rPr>
              <a:t>whole genome sequencing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. Genotypes are then compared to available data. Such comparisons are greatly facilitated by the making of </a:t>
            </a:r>
            <a:r>
              <a:rPr b="1" lang="fr-FR" sz="3600" spc="-1" strike="noStrike">
                <a:solidFill>
                  <a:srgbClr val="000000"/>
                </a:solidFill>
                <a:latin typeface="Calibri"/>
              </a:rPr>
              <a:t>cooperative databases accessible over the internet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. In order to create such databases, available data need to be compiled from the litterature or extracted from public genome sequence data. 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ZoneTexte 11"/>
          <p:cNvSpPr/>
          <p:nvPr/>
        </p:nvSpPr>
        <p:spPr>
          <a:xfrm>
            <a:off x="22286520" y="21829680"/>
            <a:ext cx="38185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319640"/>
                <a:tab algn="l" pos="8639280"/>
              </a:tabLst>
            </a:pPr>
            <a:r>
              <a:rPr b="1" lang="fr-FR" sz="3600" spc="-1" strike="noStrike">
                <a:solidFill>
                  <a:srgbClr val="000000"/>
                </a:solidFill>
                <a:latin typeface="Calibri"/>
              </a:rPr>
              <a:t>Database browsing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ZoneTexte 15"/>
          <p:cNvSpPr/>
          <p:nvPr/>
        </p:nvSpPr>
        <p:spPr>
          <a:xfrm>
            <a:off x="22672800" y="28670400"/>
            <a:ext cx="3166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319640"/>
                <a:tab algn="l" pos="863928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Database query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ZoneTexte 12"/>
          <p:cNvSpPr/>
          <p:nvPr/>
        </p:nvSpPr>
        <p:spPr>
          <a:xfrm>
            <a:off x="26155800" y="35437680"/>
            <a:ext cx="3115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319640"/>
                <a:tab algn="l" pos="863928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Geolocalisation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ZoneTexte 17"/>
          <p:cNvSpPr/>
          <p:nvPr/>
        </p:nvSpPr>
        <p:spPr>
          <a:xfrm>
            <a:off x="19160280" y="35506080"/>
            <a:ext cx="21938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319640"/>
                <a:tab algn="l" pos="863928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Clustering 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ZoneTexte 14"/>
          <p:cNvSpPr/>
          <p:nvPr/>
        </p:nvSpPr>
        <p:spPr>
          <a:xfrm>
            <a:off x="6192720" y="4537080"/>
            <a:ext cx="200185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319640"/>
                <a:tab algn="l" pos="8639280"/>
              </a:tabLst>
            </a:pPr>
            <a:r>
              <a:rPr b="0" lang="en-US" sz="3600" spc="-1" strike="noStrike">
                <a:solidFill>
                  <a:srgbClr val="4f81bd"/>
                </a:solidFill>
                <a:latin typeface="Calibri"/>
              </a:rPr>
              <a:t>Full text at 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319640"/>
                <a:tab algn="l" pos="8639280"/>
              </a:tabLst>
            </a:pPr>
            <a:r>
              <a:rPr b="0" lang="en-US" sz="3600" spc="-1" strike="noStrike">
                <a:solidFill>
                  <a:srgbClr val="4f81bd"/>
                </a:solidFill>
                <a:latin typeface="Calibri"/>
              </a:rPr>
              <a:t>http://mlva.u-psud.fr/MLVAnet/IMG/pdf/MlvaBank_tutorial.pdf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ZoneTexte 15"/>
          <p:cNvSpPr/>
          <p:nvPr/>
        </p:nvSpPr>
        <p:spPr>
          <a:xfrm>
            <a:off x="1728720" y="14670000"/>
            <a:ext cx="1375272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319640"/>
                <a:tab algn="l" pos="8639280"/>
              </a:tabLst>
            </a:pPr>
            <a:r>
              <a:rPr b="1" lang="en-US" sz="3600" spc="-1" strike="noStrike">
                <a:solidFill>
                  <a:srgbClr val="cc6600"/>
                </a:solidFill>
                <a:latin typeface="Calibri"/>
              </a:rPr>
              <a:t>Step 1</a:t>
            </a:r>
            <a:r>
              <a:rPr b="0" lang="en-US" sz="3600" spc="-1" strike="noStrike">
                <a:solidFill>
                  <a:srgbClr val="cc6600"/>
                </a:solidFill>
                <a:latin typeface="Calibri"/>
              </a:rPr>
              <a:t>: </a:t>
            </a:r>
            <a:r>
              <a:rPr b="1" lang="en-US" sz="3600" spc="-1" strike="noStrike">
                <a:solidFill>
                  <a:srgbClr val="cc6600"/>
                </a:solidFill>
                <a:latin typeface="Calibri"/>
              </a:rPr>
              <a:t>Exploiting published genomes sequence data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4319640"/>
                <a:tab algn="l" pos="8639280"/>
              </a:tabLst>
            </a:pP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MLVAbank includes tools for </a:t>
            </a:r>
            <a:r>
              <a:rPr b="1" i="1" lang="fr-FR" sz="3600" spc="-1" strike="noStrike">
                <a:solidFill>
                  <a:srgbClr val="000000"/>
                </a:solidFill>
                <a:latin typeface="Calibri"/>
              </a:rPr>
              <a:t>in silico </a:t>
            </a:r>
            <a:r>
              <a:rPr b="1" lang="fr-FR" sz="3600" spc="-1" strike="noStrike">
                <a:solidFill>
                  <a:srgbClr val="000000"/>
                </a:solidFill>
                <a:latin typeface="Calibri"/>
              </a:rPr>
              <a:t>genotyping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. MLVA and SNP typing data is deduced from available genome sequences. 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3" name="Connecteur droit avec flèche 19"/>
          <p:cNvCxnSpPr/>
          <p:nvPr/>
        </p:nvCxnSpPr>
        <p:spPr>
          <a:xfrm flipH="1" flipV="1">
            <a:off x="9224640" y="19500480"/>
            <a:ext cx="1792800" cy="10080"/>
          </a:xfrm>
          <a:prstGeom prst="straightConnector1">
            <a:avLst/>
          </a:prstGeom>
          <a:ln w="4428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64" name="ZoneTexte 21"/>
          <p:cNvSpPr/>
          <p:nvPr/>
        </p:nvSpPr>
        <p:spPr>
          <a:xfrm>
            <a:off x="11017080" y="18578520"/>
            <a:ext cx="5021280" cy="180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319640"/>
                <a:tab algn="l" pos="863928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Calibri"/>
              </a:rPr>
              <a:t>Genome sequence to analyse corresponding to a single strain (may contain more than one fasta file)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ZoneTexte 24"/>
          <p:cNvSpPr/>
          <p:nvPr/>
        </p:nvSpPr>
        <p:spPr>
          <a:xfrm>
            <a:off x="11088720" y="21845520"/>
            <a:ext cx="35910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319640"/>
                <a:tab algn="l" pos="863928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Calibri"/>
              </a:rPr>
              <a:t>Primers for MLVA 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ZoneTexte 26"/>
          <p:cNvSpPr/>
          <p:nvPr/>
        </p:nvSpPr>
        <p:spPr>
          <a:xfrm>
            <a:off x="11017080" y="24539400"/>
            <a:ext cx="5021280" cy="180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319640"/>
                <a:tab algn="l" pos="863928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Calibri"/>
              </a:rPr>
              <a:t>Reference genome sequence for SNP  positioning. May contain more than one fasta file (e.g., plasmids, contigs )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ZoneTexte 28"/>
          <p:cNvSpPr/>
          <p:nvPr/>
        </p:nvSpPr>
        <p:spPr>
          <a:xfrm>
            <a:off x="11017080" y="26773200"/>
            <a:ext cx="5021280" cy="22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319640"/>
                <a:tab algn="l" pos="863928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Calibri"/>
              </a:rPr>
              <a:t>List of SNP positions. If several fasta files are used, a key word from the fasta heading  needs to be specified for each SNP (for instance, “chromosome”)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ZoneTexte 30"/>
          <p:cNvSpPr/>
          <p:nvPr/>
        </p:nvSpPr>
        <p:spPr>
          <a:xfrm>
            <a:off x="11017080" y="29379960"/>
            <a:ext cx="5021280" cy="180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319640"/>
                <a:tab algn="l" pos="863928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Calibri"/>
              </a:rPr>
              <a:t>Output table. One line will be added for each genome analysis. The csv export file can then be used to create a first database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" name="Picture 19" descr="Université Paris-Sud XI"/>
          <p:cNvPicPr/>
          <p:nvPr/>
        </p:nvPicPr>
        <p:blipFill>
          <a:blip r:embed="rId8"/>
          <a:stretch/>
        </p:blipFill>
        <p:spPr>
          <a:xfrm>
            <a:off x="336600" y="-647640"/>
            <a:ext cx="571320" cy="57132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21" descr="Université Paris-Sud XI"/>
          <p:cNvPicPr/>
          <p:nvPr/>
        </p:nvPicPr>
        <p:blipFill>
          <a:blip r:embed="rId9"/>
          <a:stretch/>
        </p:blipFill>
        <p:spPr>
          <a:xfrm>
            <a:off x="336600" y="-647640"/>
            <a:ext cx="571320" cy="571320"/>
          </a:xfrm>
          <a:prstGeom prst="rect">
            <a:avLst/>
          </a:prstGeom>
          <a:ln w="0">
            <a:noFill/>
          </a:ln>
        </p:spPr>
      </p:pic>
      <p:pic>
        <p:nvPicPr>
          <p:cNvPr id="71" name="Image 34" descr="logo_upsud.png"/>
          <p:cNvPicPr/>
          <p:nvPr/>
        </p:nvPicPr>
        <p:blipFill>
          <a:blip r:embed="rId10"/>
          <a:stretch/>
        </p:blipFill>
        <p:spPr>
          <a:xfrm>
            <a:off x="2998800" y="40925880"/>
            <a:ext cx="2867040" cy="1584360"/>
          </a:xfrm>
          <a:prstGeom prst="rect">
            <a:avLst/>
          </a:prstGeom>
          <a:ln w="0">
            <a:noFill/>
          </a:ln>
        </p:spPr>
      </p:pic>
      <p:sp>
        <p:nvSpPr>
          <p:cNvPr id="72" name="ZoneTexte 35"/>
          <p:cNvSpPr/>
          <p:nvPr/>
        </p:nvSpPr>
        <p:spPr>
          <a:xfrm>
            <a:off x="1744560" y="32618520"/>
            <a:ext cx="1373688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319640"/>
                <a:tab algn="l" pos="8639280"/>
              </a:tabLst>
            </a:pPr>
            <a:r>
              <a:rPr b="1" lang="en-US" sz="3600" spc="-1" strike="noStrike">
                <a:solidFill>
                  <a:srgbClr val="cc6600"/>
                </a:solidFill>
                <a:latin typeface="Calibri"/>
              </a:rPr>
              <a:t>Step 2</a:t>
            </a:r>
            <a:r>
              <a:rPr b="0" lang="en-US" sz="3600" spc="-1" strike="noStrike">
                <a:solidFill>
                  <a:srgbClr val="cc6600"/>
                </a:solidFill>
                <a:latin typeface="Calibri"/>
              </a:rPr>
              <a:t>: </a:t>
            </a:r>
            <a:r>
              <a:rPr b="1" lang="en-US" sz="3600" spc="-1" strike="noStrike">
                <a:solidFill>
                  <a:srgbClr val="cc6600"/>
                </a:solidFill>
                <a:latin typeface="Calibri"/>
              </a:rPr>
              <a:t>Compiling MLVA and SNP genotyping data from the literature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4319640"/>
                <a:tab algn="l" pos="8639280"/>
              </a:tabLst>
            </a:pP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The different dataset from each article need to be checked to harmonise conventions. </a:t>
            </a:r>
            <a:r>
              <a:rPr b="1" lang="fr-FR" sz="3600" spc="-1" strike="noStrike">
                <a:solidFill>
                  <a:srgbClr val="000000"/>
                </a:solidFill>
                <a:latin typeface="Calibri"/>
              </a:rPr>
              <a:t>The first published convention should be used, except  if an error had to be subsequently corrected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.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ZoneTexte 38"/>
          <p:cNvSpPr/>
          <p:nvPr/>
        </p:nvSpPr>
        <p:spPr>
          <a:xfrm>
            <a:off x="17714880" y="7924680"/>
            <a:ext cx="12961800" cy="448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319640"/>
                <a:tab algn="l" pos="8639280"/>
              </a:tabLst>
            </a:pPr>
            <a:r>
              <a:rPr b="1" lang="en-US" sz="3600" spc="-1" strike="noStrike">
                <a:solidFill>
                  <a:srgbClr val="cc6600"/>
                </a:solidFill>
                <a:latin typeface="Calibri"/>
              </a:rPr>
              <a:t>Step 3</a:t>
            </a:r>
            <a:r>
              <a:rPr b="0" lang="en-US" sz="3600" spc="-1" strike="noStrike">
                <a:solidFill>
                  <a:srgbClr val="cc6600"/>
                </a:solidFill>
                <a:latin typeface="Calibri"/>
              </a:rPr>
              <a:t>: </a:t>
            </a:r>
            <a:r>
              <a:rPr b="1" lang="en-US" sz="3600" spc="-1" strike="noStrike">
                <a:solidFill>
                  <a:srgbClr val="cc6600"/>
                </a:solidFill>
                <a:latin typeface="Calibri"/>
              </a:rPr>
              <a:t>Creation of a cooperative database in MLVAbank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4319640"/>
                <a:tab algn="l" pos="8639280"/>
              </a:tabLst>
            </a:pP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MLVAbank allows the creation of cooperative databases which integrate multiple independant databases and any numeric data (MLVA, MLST, SNPs, CRISPRs, Spoligotyping). </a:t>
            </a:r>
            <a:r>
              <a:rPr b="1" lang="fr-FR" sz="3600" spc="-1" strike="noStrike">
                <a:solidFill>
                  <a:srgbClr val="000000"/>
                </a:solidFill>
                <a:latin typeface="Calibri"/>
              </a:rPr>
              <a:t>For instance, three databases 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are listed here for </a:t>
            </a:r>
            <a:r>
              <a:rPr b="0" i="1" lang="fr-FR" sz="3600" spc="-1" strike="noStrike">
                <a:solidFill>
                  <a:srgbClr val="000000"/>
                </a:solidFill>
                <a:latin typeface="Calibri"/>
              </a:rPr>
              <a:t>B. anthracis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, one based on </a:t>
            </a:r>
            <a:r>
              <a:rPr b="0" i="1" lang="fr-FR" sz="3600" spc="-1" strike="noStrike">
                <a:solidFill>
                  <a:srgbClr val="000000"/>
                </a:solidFill>
                <a:latin typeface="Calibri"/>
              </a:rPr>
              <a:t>in silico 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genome sequence data, and two based on published MLVA/SNP data. They constitute </a:t>
            </a:r>
            <a:r>
              <a:rPr b="1" lang="fr-FR" sz="3600" spc="-1" strike="noStrike">
                <a:solidFill>
                  <a:srgbClr val="000000"/>
                </a:solidFill>
                <a:latin typeface="Calibri"/>
              </a:rPr>
              <a:t>the public </a:t>
            </a:r>
            <a:r>
              <a:rPr b="1" i="1" lang="fr-FR" sz="3600" spc="-1" strike="noStrike">
                <a:solidFill>
                  <a:srgbClr val="000000"/>
                </a:solidFill>
                <a:latin typeface="Calibri"/>
              </a:rPr>
              <a:t>Bacillus_anthracis</a:t>
            </a:r>
            <a:r>
              <a:rPr b="1" lang="fr-FR" sz="3600" spc="-1" strike="noStrike">
                <a:solidFill>
                  <a:srgbClr val="000000"/>
                </a:solidFill>
                <a:latin typeface="Calibri"/>
              </a:rPr>
              <a:t> cooperative database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. Additional databases can be added.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ZoneTexte 40"/>
          <p:cNvSpPr/>
          <p:nvPr/>
        </p:nvSpPr>
        <p:spPr>
          <a:xfrm>
            <a:off x="17857800" y="19857960"/>
            <a:ext cx="1281744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319640"/>
                <a:tab algn="l" pos="8639280"/>
              </a:tabLst>
            </a:pPr>
            <a:r>
              <a:rPr b="1" lang="en-US" sz="3600" spc="-1" strike="noStrike">
                <a:solidFill>
                  <a:srgbClr val="cc6600"/>
                </a:solidFill>
                <a:latin typeface="Calibri"/>
              </a:rPr>
              <a:t>Step 4</a:t>
            </a:r>
            <a:r>
              <a:rPr b="0" lang="en-US" sz="3600" spc="-1" strike="noStrike">
                <a:solidFill>
                  <a:srgbClr val="cc6600"/>
                </a:solidFill>
                <a:latin typeface="Calibri"/>
              </a:rPr>
              <a:t>: </a:t>
            </a:r>
            <a:r>
              <a:rPr b="1" lang="en-US" sz="3600" spc="-1" strike="noStrike">
                <a:solidFill>
                  <a:srgbClr val="cc6600"/>
                </a:solidFill>
                <a:latin typeface="Calibri"/>
              </a:rPr>
              <a:t>Using the database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319640"/>
                <a:tab algn="l" pos="8639280"/>
              </a:tabLst>
            </a:pP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The resulting database can be viewed and queried. It includes </a:t>
            </a:r>
            <a:r>
              <a:rPr b="1" lang="fr-FR" sz="3600" spc="-1" strike="noStrike">
                <a:solidFill>
                  <a:srgbClr val="000000"/>
                </a:solidFill>
                <a:latin typeface="Calibri"/>
              </a:rPr>
              <a:t>links to the source publications </a:t>
            </a:r>
            <a:r>
              <a:rPr b="0" lang="fr-FR" sz="3600" spc="-1" strike="noStrike">
                <a:solidFill>
                  <a:srgbClr val="000000"/>
                </a:solidFill>
                <a:latin typeface="Calibri"/>
              </a:rPr>
              <a:t>and associated corresponding author.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5" name="Connecteur droit avec flèche 37"/>
          <p:cNvCxnSpPr/>
          <p:nvPr/>
        </p:nvCxnSpPr>
        <p:spPr>
          <a:xfrm flipH="1" flipV="1">
            <a:off x="9224640" y="22080240"/>
            <a:ext cx="1792800" cy="10080"/>
          </a:xfrm>
          <a:prstGeom prst="straightConnector1">
            <a:avLst/>
          </a:prstGeom>
          <a:ln w="442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76" name="Connecteur droit avec flèche 38"/>
          <p:cNvCxnSpPr/>
          <p:nvPr/>
        </p:nvCxnSpPr>
        <p:spPr>
          <a:xfrm flipH="1">
            <a:off x="9154080" y="25368480"/>
            <a:ext cx="1919160" cy="903960"/>
          </a:xfrm>
          <a:prstGeom prst="straightConnector1">
            <a:avLst/>
          </a:prstGeom>
          <a:ln w="442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77" name="Connecteur droit avec flèche 40"/>
          <p:cNvCxnSpPr/>
          <p:nvPr/>
        </p:nvCxnSpPr>
        <p:spPr>
          <a:xfrm flipH="1">
            <a:off x="9216720" y="27914760"/>
            <a:ext cx="1800720" cy="575280"/>
          </a:xfrm>
          <a:prstGeom prst="straightConnector1">
            <a:avLst/>
          </a:prstGeom>
          <a:ln w="442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78" name="Connecteur droit avec flèche 42"/>
          <p:cNvCxnSpPr/>
          <p:nvPr/>
        </p:nvCxnSpPr>
        <p:spPr>
          <a:xfrm flipH="1" flipV="1">
            <a:off x="9224640" y="30375000"/>
            <a:ext cx="1792800" cy="10080"/>
          </a:xfrm>
          <a:prstGeom prst="straightConnector1">
            <a:avLst/>
          </a:prstGeom>
          <a:ln w="44280">
            <a:solidFill>
              <a:srgbClr val="ff0000"/>
            </a:solidFill>
            <a:miter/>
            <a:tailEnd len="med" type="arrow" w="med"/>
          </a:ln>
        </p:spPr>
      </p:cxnSp>
      <p:pic>
        <p:nvPicPr>
          <p:cNvPr id="79" name="Picture 36" descr=""/>
          <p:cNvPicPr/>
          <p:nvPr/>
        </p:nvPicPr>
        <p:blipFill>
          <a:blip r:embed="rId11"/>
          <a:stretch/>
        </p:blipFill>
        <p:spPr>
          <a:xfrm>
            <a:off x="3024360" y="36174240"/>
            <a:ext cx="10585440" cy="371808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39" descr=""/>
          <p:cNvPicPr/>
          <p:nvPr/>
        </p:nvPicPr>
        <p:blipFill>
          <a:blip r:embed="rId12"/>
          <a:stretch/>
        </p:blipFill>
        <p:spPr>
          <a:xfrm>
            <a:off x="19931040" y="12783960"/>
            <a:ext cx="8529840" cy="623268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7" descr="ANSES_Logo"/>
          <p:cNvPicPr/>
          <p:nvPr/>
        </p:nvPicPr>
        <p:blipFill>
          <a:blip r:embed="rId13"/>
          <a:srcRect l="0" t="14681" r="0" b="0"/>
          <a:stretch/>
        </p:blipFill>
        <p:spPr>
          <a:xfrm>
            <a:off x="9721800" y="40733640"/>
            <a:ext cx="4275360" cy="1967040"/>
          </a:xfrm>
          <a:prstGeom prst="rect">
            <a:avLst/>
          </a:prstGeom>
          <a:ln w="0">
            <a:noFill/>
          </a:ln>
        </p:spPr>
      </p:pic>
      <p:sp>
        <p:nvSpPr>
          <p:cNvPr id="82" name="ZoneTexte 45"/>
          <p:cNvSpPr/>
          <p:nvPr/>
        </p:nvSpPr>
        <p:spPr>
          <a:xfrm>
            <a:off x="29660400" y="42053040"/>
            <a:ext cx="2239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319640"/>
                <a:tab algn="l" pos="863928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Version 1.0 jan2014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10T07:00:43Z</dcterms:created>
  <dc:creator>Thierry et al.</dc:creator>
  <dc:description/>
  <dc:language>en-US</dc:language>
  <cp:lastModifiedBy>Gilles Vergnaud</cp:lastModifiedBy>
  <dcterms:modified xsi:type="dcterms:W3CDTF">2014-01-27T15:12:38Z</dcterms:modified>
  <cp:revision>37</cp:revision>
  <dc:subject/>
  <dc:title>supplementary file 2</dc:title>
</cp:coreProperties>
</file>